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4"/>
  </p:notesMasterIdLst>
  <p:sldIdLst>
    <p:sldId id="256" r:id="rId2"/>
    <p:sldId id="294" r:id="rId3"/>
    <p:sldId id="291" r:id="rId4"/>
    <p:sldId id="292" r:id="rId5"/>
    <p:sldId id="293" r:id="rId6"/>
    <p:sldId id="498" r:id="rId7"/>
    <p:sldId id="310" r:id="rId8"/>
    <p:sldId id="307" r:id="rId9"/>
    <p:sldId id="308" r:id="rId10"/>
    <p:sldId id="309" r:id="rId11"/>
    <p:sldId id="499" r:id="rId12"/>
    <p:sldId id="314" r:id="rId13"/>
    <p:sldId id="315" r:id="rId14"/>
    <p:sldId id="316" r:id="rId15"/>
    <p:sldId id="500" r:id="rId16"/>
    <p:sldId id="323" r:id="rId17"/>
    <p:sldId id="320" r:id="rId18"/>
    <p:sldId id="321" r:id="rId19"/>
    <p:sldId id="322" r:id="rId20"/>
    <p:sldId id="501" r:id="rId21"/>
    <p:sldId id="327" r:id="rId22"/>
    <p:sldId id="325" r:id="rId23"/>
    <p:sldId id="331" r:id="rId24"/>
    <p:sldId id="326" r:id="rId25"/>
    <p:sldId id="502" r:id="rId26"/>
    <p:sldId id="338" r:id="rId27"/>
    <p:sldId id="340" r:id="rId28"/>
    <p:sldId id="341" r:id="rId29"/>
    <p:sldId id="342" r:id="rId30"/>
    <p:sldId id="503" r:id="rId31"/>
    <p:sldId id="354" r:id="rId32"/>
    <p:sldId id="350" r:id="rId33"/>
    <p:sldId id="351" r:id="rId34"/>
    <p:sldId id="352" r:id="rId35"/>
    <p:sldId id="504" r:id="rId36"/>
    <p:sldId id="370" r:id="rId37"/>
    <p:sldId id="371" r:id="rId38"/>
    <p:sldId id="372" r:id="rId39"/>
    <p:sldId id="373" r:id="rId40"/>
    <p:sldId id="505" r:id="rId41"/>
    <p:sldId id="495" r:id="rId42"/>
    <p:sldId id="377" r:id="rId43"/>
    <p:sldId id="388" r:id="rId44"/>
    <p:sldId id="387" r:id="rId45"/>
    <p:sldId id="506" r:id="rId46"/>
    <p:sldId id="497" r:id="rId47"/>
    <p:sldId id="386" r:id="rId48"/>
    <p:sldId id="385" r:id="rId49"/>
    <p:sldId id="384" r:id="rId50"/>
    <p:sldId id="507" r:id="rId51"/>
    <p:sldId id="392" r:id="rId52"/>
    <p:sldId id="383" r:id="rId53"/>
    <p:sldId id="391" r:id="rId54"/>
    <p:sldId id="390" r:id="rId55"/>
    <p:sldId id="508" r:id="rId56"/>
    <p:sldId id="389" r:id="rId57"/>
    <p:sldId id="394" r:id="rId58"/>
    <p:sldId id="393" r:id="rId59"/>
    <p:sldId id="509" r:id="rId60"/>
    <p:sldId id="400" r:id="rId61"/>
    <p:sldId id="399" r:id="rId62"/>
    <p:sldId id="398" r:id="rId63"/>
    <p:sldId id="396" r:id="rId64"/>
    <p:sldId id="510" r:id="rId65"/>
    <p:sldId id="395" r:id="rId66"/>
    <p:sldId id="403" r:id="rId67"/>
    <p:sldId id="402" r:id="rId68"/>
    <p:sldId id="511" r:id="rId69"/>
    <p:sldId id="407" r:id="rId70"/>
    <p:sldId id="406" r:id="rId71"/>
    <p:sldId id="404" r:id="rId72"/>
    <p:sldId id="405" r:id="rId73"/>
    <p:sldId id="512" r:id="rId74"/>
    <p:sldId id="415" r:id="rId75"/>
    <p:sldId id="419" r:id="rId76"/>
    <p:sldId id="420" r:id="rId77"/>
    <p:sldId id="421" r:id="rId78"/>
    <p:sldId id="515" r:id="rId79"/>
    <p:sldId id="433" r:id="rId80"/>
    <p:sldId id="434" r:id="rId81"/>
    <p:sldId id="435" r:id="rId82"/>
    <p:sldId id="436" r:id="rId83"/>
    <p:sldId id="517" r:id="rId84"/>
    <p:sldId id="437" r:id="rId85"/>
    <p:sldId id="438" r:id="rId86"/>
    <p:sldId id="439" r:id="rId87"/>
    <p:sldId id="440" r:id="rId88"/>
    <p:sldId id="518" r:id="rId89"/>
    <p:sldId id="444" r:id="rId90"/>
    <p:sldId id="445" r:id="rId91"/>
    <p:sldId id="446" r:id="rId92"/>
    <p:sldId id="447" r:id="rId93"/>
    <p:sldId id="519" r:id="rId94"/>
    <p:sldId id="448" r:id="rId95"/>
    <p:sldId id="449" r:id="rId96"/>
    <p:sldId id="450" r:id="rId97"/>
    <p:sldId id="520" r:id="rId98"/>
    <p:sldId id="457" r:id="rId99"/>
    <p:sldId id="458" r:id="rId100"/>
    <p:sldId id="459" r:id="rId101"/>
    <p:sldId id="460" r:id="rId102"/>
    <p:sldId id="522" r:id="rId103"/>
    <p:sldId id="468" r:id="rId104"/>
    <p:sldId id="469" r:id="rId105"/>
    <p:sldId id="470" r:id="rId106"/>
    <p:sldId id="471" r:id="rId107"/>
    <p:sldId id="524" r:id="rId108"/>
    <p:sldId id="477" r:id="rId109"/>
    <p:sldId id="481" r:id="rId110"/>
    <p:sldId id="482" r:id="rId111"/>
    <p:sldId id="483" r:id="rId112"/>
    <p:sldId id="527" r:id="rId1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 autoAdjust="0"/>
    <p:restoredTop sz="94676" autoAdjust="0"/>
  </p:normalViewPr>
  <p:slideViewPr>
    <p:cSldViewPr>
      <p:cViewPr>
        <p:scale>
          <a:sx n="86" d="100"/>
          <a:sy n="86" d="100"/>
        </p:scale>
        <p:origin x="-1410" y="-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117" Type="http://schemas.openxmlformats.org/officeDocument/2006/relationships/theme" Target="theme/theme1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84" Type="http://schemas.openxmlformats.org/officeDocument/2006/relationships/slide" Target="slides/slide83.xml"/><Relationship Id="rId89" Type="http://schemas.openxmlformats.org/officeDocument/2006/relationships/slide" Target="slides/slide88.xml"/><Relationship Id="rId112" Type="http://schemas.openxmlformats.org/officeDocument/2006/relationships/slide" Target="slides/slide111.xml"/><Relationship Id="rId16" Type="http://schemas.openxmlformats.org/officeDocument/2006/relationships/slide" Target="slides/slide15.xml"/><Relationship Id="rId107" Type="http://schemas.openxmlformats.org/officeDocument/2006/relationships/slide" Target="slides/slide106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102" Type="http://schemas.openxmlformats.org/officeDocument/2006/relationships/slide" Target="slides/slide101.xml"/><Relationship Id="rId5" Type="http://schemas.openxmlformats.org/officeDocument/2006/relationships/slide" Target="slides/slide4.xml"/><Relationship Id="rId90" Type="http://schemas.openxmlformats.org/officeDocument/2006/relationships/slide" Target="slides/slide89.xml"/><Relationship Id="rId95" Type="http://schemas.openxmlformats.org/officeDocument/2006/relationships/slide" Target="slides/slide94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113" Type="http://schemas.openxmlformats.org/officeDocument/2006/relationships/slide" Target="slides/slide112.xml"/><Relationship Id="rId118" Type="http://schemas.openxmlformats.org/officeDocument/2006/relationships/tableStyles" Target="tableStyles.xml"/><Relationship Id="rId80" Type="http://schemas.openxmlformats.org/officeDocument/2006/relationships/slide" Target="slides/slide79.xml"/><Relationship Id="rId85" Type="http://schemas.openxmlformats.org/officeDocument/2006/relationships/slide" Target="slides/slide84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59" Type="http://schemas.openxmlformats.org/officeDocument/2006/relationships/slide" Target="slides/slide58.xml"/><Relationship Id="rId103" Type="http://schemas.openxmlformats.org/officeDocument/2006/relationships/slide" Target="slides/slide102.xml"/><Relationship Id="rId108" Type="http://schemas.openxmlformats.org/officeDocument/2006/relationships/slide" Target="slides/slide107.xml"/><Relationship Id="rId54" Type="http://schemas.openxmlformats.org/officeDocument/2006/relationships/slide" Target="slides/slide53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91" Type="http://schemas.openxmlformats.org/officeDocument/2006/relationships/slide" Target="slides/slide90.xml"/><Relationship Id="rId96" Type="http://schemas.openxmlformats.org/officeDocument/2006/relationships/slide" Target="slides/slide95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49" Type="http://schemas.openxmlformats.org/officeDocument/2006/relationships/slide" Target="slides/slide48.xml"/><Relationship Id="rId114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slide" Target="slides/slide80.xml"/><Relationship Id="rId86" Type="http://schemas.openxmlformats.org/officeDocument/2006/relationships/slide" Target="slides/slide85.xml"/><Relationship Id="rId94" Type="http://schemas.openxmlformats.org/officeDocument/2006/relationships/slide" Target="slides/slide93.xml"/><Relationship Id="rId99" Type="http://schemas.openxmlformats.org/officeDocument/2006/relationships/slide" Target="slides/slide98.xml"/><Relationship Id="rId101" Type="http://schemas.openxmlformats.org/officeDocument/2006/relationships/slide" Target="slides/slide10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109" Type="http://schemas.openxmlformats.org/officeDocument/2006/relationships/slide" Target="slides/slide10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97" Type="http://schemas.openxmlformats.org/officeDocument/2006/relationships/slide" Target="slides/slide96.xml"/><Relationship Id="rId104" Type="http://schemas.openxmlformats.org/officeDocument/2006/relationships/slide" Target="slides/slide103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92" Type="http://schemas.openxmlformats.org/officeDocument/2006/relationships/slide" Target="slides/slide91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24" Type="http://schemas.openxmlformats.org/officeDocument/2006/relationships/slide" Target="slides/slide23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87" Type="http://schemas.openxmlformats.org/officeDocument/2006/relationships/slide" Target="slides/slide86.xml"/><Relationship Id="rId110" Type="http://schemas.openxmlformats.org/officeDocument/2006/relationships/slide" Target="slides/slide109.xml"/><Relationship Id="rId115" Type="http://schemas.openxmlformats.org/officeDocument/2006/relationships/presProps" Target="presProps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56" Type="http://schemas.openxmlformats.org/officeDocument/2006/relationships/slide" Target="slides/slide55.xml"/><Relationship Id="rId77" Type="http://schemas.openxmlformats.org/officeDocument/2006/relationships/slide" Target="slides/slide76.xml"/><Relationship Id="rId100" Type="http://schemas.openxmlformats.org/officeDocument/2006/relationships/slide" Target="slides/slide99.xml"/><Relationship Id="rId105" Type="http://schemas.openxmlformats.org/officeDocument/2006/relationships/slide" Target="slides/slide104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93" Type="http://schemas.openxmlformats.org/officeDocument/2006/relationships/slide" Target="slides/slide92.xml"/><Relationship Id="rId98" Type="http://schemas.openxmlformats.org/officeDocument/2006/relationships/slide" Target="slides/slide97.xml"/><Relationship Id="rId3" Type="http://schemas.openxmlformats.org/officeDocument/2006/relationships/slide" Target="slides/slide2.xml"/><Relationship Id="rId25" Type="http://schemas.openxmlformats.org/officeDocument/2006/relationships/slide" Target="slides/slide24.xml"/><Relationship Id="rId46" Type="http://schemas.openxmlformats.org/officeDocument/2006/relationships/slide" Target="slides/slide45.xml"/><Relationship Id="rId67" Type="http://schemas.openxmlformats.org/officeDocument/2006/relationships/slide" Target="slides/slide66.xml"/><Relationship Id="rId116" Type="http://schemas.openxmlformats.org/officeDocument/2006/relationships/viewProps" Target="viewProp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62" Type="http://schemas.openxmlformats.org/officeDocument/2006/relationships/slide" Target="slides/slide61.xml"/><Relationship Id="rId83" Type="http://schemas.openxmlformats.org/officeDocument/2006/relationships/slide" Target="slides/slide82.xml"/><Relationship Id="rId88" Type="http://schemas.openxmlformats.org/officeDocument/2006/relationships/slide" Target="slides/slide87.xml"/><Relationship Id="rId111" Type="http://schemas.openxmlformats.org/officeDocument/2006/relationships/slide" Target="slides/slide110.xml"/><Relationship Id="rId15" Type="http://schemas.openxmlformats.org/officeDocument/2006/relationships/slide" Target="slides/slide14.xml"/><Relationship Id="rId36" Type="http://schemas.openxmlformats.org/officeDocument/2006/relationships/slide" Target="slides/slide35.xml"/><Relationship Id="rId57" Type="http://schemas.openxmlformats.org/officeDocument/2006/relationships/slide" Target="slides/slide56.xml"/><Relationship Id="rId106" Type="http://schemas.openxmlformats.org/officeDocument/2006/relationships/slide" Target="slides/slide105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418B5-FCC3-44D7-AE3B-1F5CD282B906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069ED3-932A-4194-B6D7-321CDF6D6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29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069ED3-932A-4194-B6D7-321CDF6D6878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298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069ED3-932A-4194-B6D7-321CDF6D6878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298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069ED3-932A-4194-B6D7-321CDF6D6878}" type="slidenum">
              <a:rPr lang="en-US" smtClean="0"/>
              <a:t>4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298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069ED3-932A-4194-B6D7-321CDF6D6878}" type="slidenum">
              <a:rPr lang="en-US" smtClean="0"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2981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AD325F-8D0E-4D6C-AA9A-484D1A0AD6B7}" type="slidenum">
              <a:rPr lang="en-US" smtClean="0"/>
              <a:pPr/>
              <a:t>10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834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AD325F-8D0E-4D6C-AA9A-484D1A0AD6B7}" type="slidenum">
              <a:rPr lang="en-US" smtClean="0"/>
              <a:pPr/>
              <a:t>10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8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714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013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647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994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980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87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611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870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13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138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921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858D3-7D4C-47E7-8128-5F518059152A}" type="datetimeFigureOut">
              <a:rPr lang="en-US" smtClean="0"/>
              <a:t>11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61197-4162-4804-91BF-282373AE3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51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10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1.xml"/></Relationships>
</file>

<file path=ppt/slides/_rels/slide10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10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10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1.xml"/></Relationships>
</file>

<file path=ppt/slides/_rels/slide10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1.xml"/></Relationships>
</file>

<file path=ppt/slides/_rels/slide10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1.xml"/></Relationships>
</file>

<file path=ppt/slides/_rels/slide10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1.xml"/></Relationships>
</file>

<file path=ppt/slides/_rels/slide10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1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1.xml"/></Relationships>
</file>

<file path=ppt/slides/_rels/slide1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png"/><Relationship Id="rId1" Type="http://schemas.openxmlformats.org/officeDocument/2006/relationships/slideLayout" Target="../slideLayouts/slideLayout1.xml"/></Relationships>
</file>

<file path=ppt/slides/_rels/slide1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1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1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1.xml"/></Relationships>
</file>

<file path=ppt/slides/_rels/slide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1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1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1.xml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1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1.xml"/></Relationships>
</file>

<file path=ppt/slides/_rels/slide8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1.xml"/></Relationships>
</file>

<file path=ppt/slides/_rels/slide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1.xml"/></Relationships>
</file>

<file path=ppt/slides/_rels/slide8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1.xml"/></Relationships>
</file>

<file path=ppt/slides/_rels/slide8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1.xml"/></Relationships>
</file>

<file path=ppt/slides/_rels/slide8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1.xml"/></Relationships>
</file>

<file path=ppt/slides/_rels/slide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9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1.xml"/></Relationships>
</file>

<file path=ppt/slides/_rels/slide9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1.xml"/></Relationships>
</file>

<file path=ppt/slides/_rels/slide9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1.xml"/></Relationships>
</file>

<file path=ppt/slides/_rels/slide9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1.xml"/></Relationships>
</file>

<file path=ppt/slides/_rels/slide9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1.xml"/></Relationships>
</file>

<file path=ppt/slides/_rels/slide9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1.xml"/></Relationships>
</file>

<file path=ppt/slides/_rels/slide9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1.xml"/></Relationships>
</file>

<file path=ppt/slides/_rels/slide9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1.xml"/></Relationships>
</file>

<file path=ppt/slides/_rels/slide9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2D-Gel additional finding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AN_090614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57029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38400"/>
            <a:ext cx="9028113" cy="2305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54063280"/>
      </p:ext>
    </p:extLst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614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0013" y="576263"/>
            <a:ext cx="8943975" cy="5705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639247905"/>
      </p:ext>
    </p:extLst>
  </p:cSld>
  <p:clrMapOvr>
    <a:masterClrMapping/>
  </p:clrMapOvr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09825"/>
            <a:ext cx="91440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59282855"/>
      </p:ext>
    </p:extLst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03189"/>
            <a:ext cx="9144000" cy="23116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38915752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46 (D672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2657912325"/>
      </p:ext>
    </p:extLst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38175" y="909638"/>
            <a:ext cx="7867650" cy="5038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480323573"/>
      </p:ext>
    </p:extLst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38188" y="1181100"/>
            <a:ext cx="7667625" cy="449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666036106"/>
      </p:ext>
    </p:extLst>
  </p:cSld>
  <p:clrMapOvr>
    <a:masterClrMapping/>
  </p:clrMapOvr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50605"/>
            <a:ext cx="9143999" cy="21214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19976145"/>
      </p:ext>
    </p:extLst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87939"/>
            <a:ext cx="9144000" cy="20602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19028146"/>
      </p:ext>
    </p:extLst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52 (D754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2568602805"/>
      </p:ext>
    </p:extLst>
  </p:cSld>
  <p:clrMapOvr>
    <a:masterClrMapping/>
  </p:clrMapOvr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5120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" y="842963"/>
            <a:ext cx="9144000" cy="5172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4105431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37866"/>
            <a:ext cx="9144000" cy="19531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13815702"/>
      </p:ext>
    </p:extLst>
  </p:cSld>
  <p:clrMapOvr>
    <a:masterClrMapping/>
  </p:clrMapOvr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522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62000" y="1347788"/>
            <a:ext cx="7620000" cy="4162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479656819"/>
      </p:ext>
    </p:extLst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24382"/>
            <a:ext cx="9144000" cy="22428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38451727"/>
      </p:ext>
    </p:extLst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88000"/>
            <a:ext cx="9143999" cy="20554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540487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2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225" y="885825"/>
            <a:ext cx="7829550" cy="5086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922713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338" y="1162050"/>
            <a:ext cx="7553325" cy="453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0016499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2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23068"/>
            <a:ext cx="9144000" cy="26251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558856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05683"/>
            <a:ext cx="9144000" cy="20758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261027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88 (N159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391406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288" y="895350"/>
            <a:ext cx="8353425" cy="5067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456961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4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250" y="1495425"/>
            <a:ext cx="8953500" cy="3867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9171924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4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72932"/>
            <a:ext cx="8991600" cy="20419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68536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84 (N1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61295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22452"/>
            <a:ext cx="9143999" cy="19447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0132919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90 (N208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531579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5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175" y="885825"/>
            <a:ext cx="7867650" cy="5086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3075939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5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813" y="1852613"/>
            <a:ext cx="8334375" cy="3152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7422020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4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05704"/>
            <a:ext cx="9067800" cy="22948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8406351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13845"/>
            <a:ext cx="8991600" cy="20867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890481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92 (N370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069547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8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700" y="904875"/>
            <a:ext cx="7848600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356199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8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3463" y="1966913"/>
            <a:ext cx="7077075" cy="2924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5986684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7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70985"/>
            <a:ext cx="8991600" cy="21105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04695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225" y="904875"/>
            <a:ext cx="7829550" cy="5048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8595978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85002"/>
            <a:ext cx="9144000" cy="18393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9243633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98 (N643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524198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0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988" y="895350"/>
            <a:ext cx="7820025" cy="5067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0694744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0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" y="1609725"/>
            <a:ext cx="8801100" cy="3638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7402770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9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22348"/>
            <a:ext cx="9067800" cy="21829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18858737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645753"/>
            <a:ext cx="9144000" cy="16690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81858816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108 (N820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4897506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3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038" y="871538"/>
            <a:ext cx="7781925" cy="5114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6919161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3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5838" y="1604963"/>
            <a:ext cx="7172325" cy="3648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162887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3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69401"/>
            <a:ext cx="8991600" cy="2231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769046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" y="1719263"/>
            <a:ext cx="8305800" cy="3419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13308948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66621"/>
            <a:ext cx="9144000" cy="1881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0526711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13 (N53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7693892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4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650" y="900113"/>
            <a:ext cx="7886700" cy="5057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86730210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5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25" y="1466850"/>
            <a:ext cx="8896350" cy="3924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83007208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5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325974"/>
            <a:ext cx="9144000" cy="2398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3284050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623483"/>
            <a:ext cx="9144000" cy="16865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55021553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25 (N157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7249245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6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988" y="909638"/>
            <a:ext cx="7820025" cy="5038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15036681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" y="914400"/>
            <a:ext cx="8915400" cy="5029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51478477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5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71642"/>
            <a:ext cx="8991599" cy="1943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753180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49087"/>
            <a:ext cx="9067800" cy="2441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04226007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612664"/>
            <a:ext cx="9144000" cy="17831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68219820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14600" y="2667000"/>
            <a:ext cx="373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N_090614_41 (N408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9897209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6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750" y="866775"/>
            <a:ext cx="7810500" cy="5124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31081260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7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775" y="1047750"/>
            <a:ext cx="8934450" cy="4762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26553104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6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07573"/>
            <a:ext cx="9144000" cy="2231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28683506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66100"/>
            <a:ext cx="8991600" cy="1948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14323664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7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175" y="890588"/>
            <a:ext cx="7867650" cy="5076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00968596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7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338" y="1271588"/>
            <a:ext cx="7553325" cy="4314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05115837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7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52403"/>
            <a:ext cx="9067800" cy="2281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1566267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36205"/>
            <a:ext cx="9144000" cy="2007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746470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73829"/>
            <a:ext cx="9144000" cy="18743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24791679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14600" y="2667000"/>
            <a:ext cx="373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N_090614_61 (N666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8132020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8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563" y="866775"/>
            <a:ext cx="7762875" cy="5124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0813476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8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8225" y="1828800"/>
            <a:ext cx="7067550" cy="320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07867933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8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24713"/>
            <a:ext cx="9144000" cy="213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66513440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23004"/>
            <a:ext cx="9144000" cy="2015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9017507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9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438" y="909638"/>
            <a:ext cx="8239125" cy="5038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68284142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9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1628775"/>
            <a:ext cx="8991600" cy="3600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68371359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9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14680"/>
            <a:ext cx="9144000" cy="21906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06782307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30446"/>
            <a:ext cx="9143999" cy="21272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6296345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14600" y="2667000"/>
            <a:ext cx="373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N_090614_71 (N777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36204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9200" y="2057400"/>
            <a:ext cx="6400800" cy="1752600"/>
          </a:xfrm>
        </p:spPr>
        <p:txBody>
          <a:bodyPr/>
          <a:lstStyle/>
          <a:p>
            <a:r>
              <a:rPr lang="en-US" dirty="0" smtClean="0"/>
              <a:t>AN_090614_86 (N11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0650876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80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413" y="881063"/>
            <a:ext cx="7877175" cy="5095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90160774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8" y="1619250"/>
            <a:ext cx="8924925" cy="3619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75690790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9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16653"/>
            <a:ext cx="9144000" cy="2260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32673104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670302"/>
            <a:ext cx="9144000" cy="19016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31586853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20 (D59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3490308249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 </a:t>
            </a:r>
            <a:endParaRPr lang="en-US" sz="5400" b="1" dirty="0"/>
          </a:p>
        </p:txBody>
      </p:sp>
      <p:pic>
        <p:nvPicPr>
          <p:cNvPr id="860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47700" y="914400"/>
            <a:ext cx="7848600" cy="502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642918718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 </a:t>
            </a:r>
            <a:endParaRPr lang="en-US" sz="5400" b="1" dirty="0"/>
          </a:p>
        </p:txBody>
      </p:sp>
      <p:pic>
        <p:nvPicPr>
          <p:cNvPr id="8704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19225" y="1738313"/>
            <a:ext cx="6305550" cy="3381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772448771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 </a:t>
            </a:r>
            <a:endParaRPr lang="en-US" sz="5400" b="1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40479"/>
            <a:ext cx="9144000" cy="1893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57041545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 </a:t>
            </a:r>
            <a:endParaRPr lang="en-US" sz="5400" b="1" dirty="0"/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13276"/>
            <a:ext cx="9144000" cy="2053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95909566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30 (D206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3377129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225" y="852488"/>
            <a:ext cx="7829550" cy="5153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03323783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23888" y="914400"/>
            <a:ext cx="7896225" cy="502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398678427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95288" y="1914525"/>
            <a:ext cx="8353425" cy="302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442857434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33078"/>
            <a:ext cx="9144000" cy="2124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77854704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41224"/>
            <a:ext cx="9144000" cy="20736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36741093"/>
      </p:ext>
    </p:extLst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32 (D255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996991637"/>
      </p:ext>
    </p:extLst>
  </p:cSld>
  <p:clrMapOvr>
    <a:masterClrMapping/>
  </p:clrMapOvr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33413" y="923925"/>
            <a:ext cx="7877175" cy="501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695831586"/>
      </p:ext>
    </p:extLst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4710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14338" y="1943100"/>
            <a:ext cx="8315325" cy="297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190064969"/>
      </p:ext>
    </p:extLst>
  </p:cSld>
  <p:clrMapOvr>
    <a:masterClrMapping/>
  </p:clrMapOvr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51700"/>
            <a:ext cx="9144000" cy="2101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18893150"/>
      </p:ext>
    </p:extLst>
  </p:cSld>
  <p:clrMapOvr>
    <a:masterClrMapping/>
  </p:clrMapOvr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544601"/>
            <a:ext cx="9144000" cy="2060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51203813"/>
      </p:ext>
    </p:extLst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34 (D403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11442818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1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363" y="1400175"/>
            <a:ext cx="8677275" cy="4057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17351154"/>
      </p:ext>
    </p:extLst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7680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38175" y="919163"/>
            <a:ext cx="7867650" cy="501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194592259"/>
      </p:ext>
    </p:extLst>
  </p:cSld>
  <p:clrMapOvr>
    <a:masterClrMapping/>
  </p:clrMapOvr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778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4775" y="1133475"/>
            <a:ext cx="8934450" cy="459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228875854"/>
      </p:ext>
    </p:extLst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505230"/>
            <a:ext cx="9067799" cy="20286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21808597"/>
      </p:ext>
    </p:extLst>
  </p:cSld>
  <p:clrMapOvr>
    <a:masterClrMapping/>
  </p:clrMapOvr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55784"/>
            <a:ext cx="9144000" cy="20971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01775496"/>
      </p:ext>
    </p:extLst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788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33413" y="909638"/>
            <a:ext cx="7877175" cy="5038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003138168"/>
      </p:ext>
    </p:extLst>
  </p:cSld>
  <p:clrMapOvr>
    <a:masterClrMapping/>
  </p:clrMapOvr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798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19100" y="1966913"/>
            <a:ext cx="8305800" cy="2924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147410496"/>
      </p:ext>
    </p:extLst>
  </p:cSld>
  <p:clrMapOvr>
    <a:masterClrMapping/>
  </p:clrMapOvr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467994"/>
            <a:ext cx="9144000" cy="2080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96176495"/>
      </p:ext>
    </p:extLst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622819"/>
            <a:ext cx="9144000" cy="19015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06871643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81000" y="2819400"/>
            <a:ext cx="8458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o-RO" sz="5400" b="1" dirty="0" smtClean="0"/>
              <a:t>AN_090614_142 (D6</a:t>
            </a:r>
            <a:r>
              <a:rPr lang="en-US" sz="5400" b="1" dirty="0" smtClean="0"/>
              <a:t>9</a:t>
            </a:r>
            <a:r>
              <a:rPr lang="ro-RO" sz="5400" b="1" dirty="0" smtClean="0"/>
              <a:t>9)</a:t>
            </a:r>
            <a:endParaRPr lang="en-US" sz="5400" b="1" dirty="0"/>
          </a:p>
        </p:txBody>
      </p:sp>
    </p:spTree>
    <p:extLst>
      <p:ext uri="{BB962C8B-B14F-4D97-AF65-F5344CB8AC3E}">
        <p14:creationId xmlns:p14="http://schemas.microsoft.com/office/powerpoint/2010/main" val="3868588598"/>
      </p:ext>
    </p:extLst>
  </p:cSld>
  <p:clrMapOvr>
    <a:masterClrMapping/>
  </p:clrMapOvr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ro-RO" dirty="0" smtClean="0"/>
              <a:t> </a:t>
            </a:r>
            <a:endParaRPr lang="en-US" dirty="0"/>
          </a:p>
        </p:txBody>
      </p:sp>
      <p:pic>
        <p:nvPicPr>
          <p:cNvPr id="6041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9125" y="923925"/>
            <a:ext cx="7905750" cy="501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95381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81</TotalTime>
  <Words>170</Words>
  <Application>Microsoft Office PowerPoint</Application>
  <PresentationFormat>On-screen Show (4:3)</PresentationFormat>
  <Paragraphs>109</Paragraphs>
  <Slides>112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2</vt:i4>
      </vt:variant>
    </vt:vector>
  </HeadingPairs>
  <TitlesOfParts>
    <vt:vector size="113" baseType="lpstr">
      <vt:lpstr>Office Theme</vt:lpstr>
      <vt:lpstr>2D-Gel additional finding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</vt:vector>
  </TitlesOfParts>
  <Company>Clarkso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D-Gel additional findings</dc:title>
  <dc:creator>Armand</dc:creator>
  <cp:lastModifiedBy>Armand</cp:lastModifiedBy>
  <cp:revision>97</cp:revision>
  <dcterms:created xsi:type="dcterms:W3CDTF">2014-09-16T15:48:38Z</dcterms:created>
  <dcterms:modified xsi:type="dcterms:W3CDTF">2014-11-24T19:08:07Z</dcterms:modified>
</cp:coreProperties>
</file>